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69" r:id="rId3"/>
    <p:sldId id="270" r:id="rId4"/>
    <p:sldId id="271" r:id="rId5"/>
    <p:sldId id="267" r:id="rId6"/>
    <p:sldId id="263" r:id="rId7"/>
    <p:sldId id="272" r:id="rId8"/>
    <p:sldId id="266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65"/>
  </p:normalViewPr>
  <p:slideViewPr>
    <p:cSldViewPr showGuides="1">
      <p:cViewPr varScale="1">
        <p:scale>
          <a:sx n="85" d="100"/>
          <a:sy n="85" d="100"/>
        </p:scale>
        <p:origin x="96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067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70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8149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618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97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3912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87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0639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707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5795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8949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DAB81B-C904-4481-9C73-F2C4C73D797B}" type="datetimeFigureOut">
              <a:rPr lang="zh-CN" altLang="en-US" smtClean="0"/>
              <a:t>2022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E02FD-7D80-4C4F-BA46-E50AA40F2F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344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348DE37-C794-D44C-B5AA-80A9B86A005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7448" y="789538"/>
            <a:ext cx="3695700" cy="26416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DC22264-F671-4685-A517-BD337943AB77}"/>
              </a:ext>
            </a:extLst>
          </p:cNvPr>
          <p:cNvSpPr txBox="1"/>
          <p:nvPr/>
        </p:nvSpPr>
        <p:spPr>
          <a:xfrm>
            <a:off x="767408" y="3789040"/>
            <a:ext cx="489654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ell viability variations in K562 cells after treatment with 3g at the indicated doses at 24,48 and 72 hours of treatment </a:t>
            </a:r>
          </a:p>
        </p:txBody>
      </p:sp>
    </p:spTree>
    <p:extLst>
      <p:ext uri="{BB962C8B-B14F-4D97-AF65-F5344CB8AC3E}">
        <p14:creationId xmlns:p14="http://schemas.microsoft.com/office/powerpoint/2010/main" val="2726607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6013F71-EB08-F344-AEFB-52D87F114C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115" y="2966282"/>
            <a:ext cx="7680176" cy="299366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8ABE424-11F2-124E-A4FB-B7D7A19F2D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344" y="-27384"/>
            <a:ext cx="7671269" cy="299366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45DAA68-5A90-004C-A09D-2A700AF3DD8C}"/>
              </a:ext>
            </a:extLst>
          </p:cNvPr>
          <p:cNvSpPr txBox="1"/>
          <p:nvPr/>
        </p:nvSpPr>
        <p:spPr>
          <a:xfrm rot="5400000">
            <a:off x="7780378" y="1385175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000" dirty="0">
                <a:latin typeface="Arial" panose="020B0604020202020204" pitchFamily="34" charset="0"/>
                <a:cs typeface="Arial" panose="020B0604020202020204" pitchFamily="34" charset="0"/>
              </a:rPr>
              <a:t>20X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45CAB68-817D-0849-9C38-A85B7E3071E0}"/>
              </a:ext>
            </a:extLst>
          </p:cNvPr>
          <p:cNvSpPr txBox="1"/>
          <p:nvPr/>
        </p:nvSpPr>
        <p:spPr>
          <a:xfrm rot="5400000">
            <a:off x="7782002" y="4409511"/>
            <a:ext cx="4106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000" dirty="0">
                <a:latin typeface="Arial" panose="020B0604020202020204" pitchFamily="34" charset="0"/>
                <a:cs typeface="Arial" panose="020B0604020202020204" pitchFamily="34" charset="0"/>
              </a:rPr>
              <a:t>40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647CD6-ECDA-4563-B11C-9500B4B609FF}"/>
              </a:ext>
            </a:extLst>
          </p:cNvPr>
          <p:cNvSpPr txBox="1"/>
          <p:nvPr/>
        </p:nvSpPr>
        <p:spPr>
          <a:xfrm>
            <a:off x="338886" y="6033463"/>
            <a:ext cx="76712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ose-dependent cell morphology variations in K562 and normal hepatocyte cells (HL7702) at the indicated 3g concentrations (20 &amp; 40X) at 72 hours of treatment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8035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73358" y="5229200"/>
            <a:ext cx="921702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CA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CA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lowcytometric analysis of apoptosis caused by indicated doses of 3g treatment at 24 and 48 h in HEL cells. </a:t>
            </a:r>
            <a:endParaRPr lang="zh-CN" altLang="zh-CN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E1E8038-2A1A-2548-888C-C9D3B215F3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368" y="249138"/>
            <a:ext cx="9499600" cy="511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66458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48FC044-4427-944C-893F-1E68B4B493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344" y="404664"/>
            <a:ext cx="9512300" cy="5118100"/>
          </a:xfrm>
          <a:prstGeom prst="rect">
            <a:avLst/>
          </a:prstGeom>
        </p:spPr>
      </p:pic>
      <p:sp>
        <p:nvSpPr>
          <p:cNvPr id="5" name="矩形 3">
            <a:extLst>
              <a:ext uri="{FF2B5EF4-FFF2-40B4-BE49-F238E27FC236}">
                <a16:creationId xmlns:a16="http://schemas.microsoft.com/office/drawing/2014/main" id="{F87DED34-CE08-4213-9199-C5022EBDE22D}"/>
              </a:ext>
            </a:extLst>
          </p:cNvPr>
          <p:cNvSpPr/>
          <p:nvPr/>
        </p:nvSpPr>
        <p:spPr>
          <a:xfrm>
            <a:off x="616295" y="5367238"/>
            <a:ext cx="921702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CA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CA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lowcytometric analysis of apoptosis caused by indicated doses of 3g treatment at 24 and 48 h in CEM-C7H2 cells. </a:t>
            </a:r>
            <a:endParaRPr lang="zh-CN" altLang="zh-CN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29019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6">
            <a:extLst>
              <a:ext uri="{FF2B5EF4-FFF2-40B4-BE49-F238E27FC236}">
                <a16:creationId xmlns:a16="http://schemas.microsoft.com/office/drawing/2014/main" id="{D2A3A78C-C3A5-524C-8417-0F1A728AC7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471" y="620688"/>
            <a:ext cx="9474200" cy="5118100"/>
          </a:xfrm>
          <a:prstGeom prst="rect">
            <a:avLst/>
          </a:prstGeom>
        </p:spPr>
      </p:pic>
      <p:sp>
        <p:nvSpPr>
          <p:cNvPr id="5" name="矩形 3">
            <a:extLst>
              <a:ext uri="{FF2B5EF4-FFF2-40B4-BE49-F238E27FC236}">
                <a16:creationId xmlns:a16="http://schemas.microsoft.com/office/drawing/2014/main" id="{72BB310C-355D-42C4-AC17-423AE87A299A}"/>
              </a:ext>
            </a:extLst>
          </p:cNvPr>
          <p:cNvSpPr/>
          <p:nvPr/>
        </p:nvSpPr>
        <p:spPr>
          <a:xfrm>
            <a:off x="658470" y="5738788"/>
            <a:ext cx="947419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CA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CA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Flowcytometric analysis of apoptosis caused by indicated doses of 3g treatment at 24 and 48 h in non-tumorous </a:t>
            </a:r>
            <a:r>
              <a:rPr lang="en-I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patocellular (HL7702)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ells. </a:t>
            </a:r>
            <a:endParaRPr lang="zh-CN" altLang="zh-CN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07671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09BFBDA-9FF4-6A42-AA4A-06E32B9A68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376" y="532189"/>
            <a:ext cx="9448800" cy="51308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C4A1233-6437-4E63-913F-1D052BEA3B1E}"/>
              </a:ext>
            </a:extLst>
          </p:cNvPr>
          <p:cNvSpPr txBox="1"/>
          <p:nvPr/>
        </p:nvSpPr>
        <p:spPr>
          <a:xfrm>
            <a:off x="695400" y="5662989"/>
            <a:ext cx="914501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 cycle arrest evaluation by flowcytometry after 24 and 48 h of 3g treatment</a:t>
            </a:r>
            <a:r>
              <a:rPr lang="en-CA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in HEL cells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7698817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9B8D0E27-9B74-4F4D-A1D7-F0D9169823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50" y="476672"/>
            <a:ext cx="9512300" cy="51181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FBB787C-4691-49BD-B702-BB9DC2728E9E}"/>
              </a:ext>
            </a:extLst>
          </p:cNvPr>
          <p:cNvSpPr txBox="1"/>
          <p:nvPr/>
        </p:nvSpPr>
        <p:spPr>
          <a:xfrm>
            <a:off x="410992" y="5497738"/>
            <a:ext cx="914501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 cycle arrest evaluation by flowcytometry after 24 and 48 h of 3g treatment</a:t>
            </a:r>
            <a:r>
              <a:rPr lang="en-CA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in CEM-C7H2  cells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6096270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A3197CA7-AAED-2D49-9125-CCE33495C0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352" y="544889"/>
            <a:ext cx="9423400" cy="51181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E0BA1F6-74D5-4822-8684-254341C761D6}"/>
              </a:ext>
            </a:extLst>
          </p:cNvPr>
          <p:cNvSpPr txBox="1"/>
          <p:nvPr/>
        </p:nvSpPr>
        <p:spPr>
          <a:xfrm>
            <a:off x="263352" y="5662989"/>
            <a:ext cx="9423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IN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CA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 cycle arrest evaluation by flowcytometry after 24 and 48 h of 3g treatment</a:t>
            </a:r>
            <a:r>
              <a:rPr lang="en-CA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in 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on-tumorous </a:t>
            </a:r>
            <a:r>
              <a:rPr lang="en-I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epatocellular (HL7702)</a:t>
            </a:r>
            <a:r>
              <a:rPr lang="en-CA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ells. 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081616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1</TotalTime>
  <Words>206</Words>
  <Application>Microsoft Macintosh PowerPoint</Application>
  <PresentationFormat>Widescreen</PresentationFormat>
  <Paragraphs>1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RAOQING</dc:creator>
  <cp:lastModifiedBy>Microsoft Office User</cp:lastModifiedBy>
  <cp:revision>38</cp:revision>
  <dcterms:created xsi:type="dcterms:W3CDTF">2022-02-15T08:55:51Z</dcterms:created>
  <dcterms:modified xsi:type="dcterms:W3CDTF">2022-03-07T05:21:56Z</dcterms:modified>
</cp:coreProperties>
</file>